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  <p:sldId id="262" r:id="rId3"/>
    <p:sldId id="263" r:id="rId4"/>
    <p:sldId id="264" r:id="rId5"/>
    <p:sldId id="265" r:id="rId6"/>
    <p:sldId id="266" r:id="rId7"/>
    <p:sldId id="267" r:id="rId8"/>
    <p:sldId id="268" r:id="rId9"/>
    <p:sldId id="269" r:id="rId10"/>
    <p:sldId id="270" r:id="rId11"/>
    <p:sldId id="271" r:id="rId1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561" autoAdjust="0"/>
    <p:restoredTop sz="96429" autoAdjust="0"/>
  </p:normalViewPr>
  <p:slideViewPr>
    <p:cSldViewPr snapToGrid="0">
      <p:cViewPr varScale="1">
        <p:scale>
          <a:sx n="109" d="100"/>
          <a:sy n="109" d="100"/>
        </p:scale>
        <p:origin x="90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F785F-9322-4B08-ADC7-7C0DBACE029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13A2-F291-4D74-BD8B-7C70315BA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71377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F785F-9322-4B08-ADC7-7C0DBACE029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13A2-F291-4D74-BD8B-7C70315BA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100066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F785F-9322-4B08-ADC7-7C0DBACE029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13A2-F291-4D74-BD8B-7C70315BA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135983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F785F-9322-4B08-ADC7-7C0DBACE029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13A2-F291-4D74-BD8B-7C70315BA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15245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F785F-9322-4B08-ADC7-7C0DBACE029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13A2-F291-4D74-BD8B-7C70315BA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103359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F785F-9322-4B08-ADC7-7C0DBACE029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13A2-F291-4D74-BD8B-7C70315BA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5481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F785F-9322-4B08-ADC7-7C0DBACE029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13A2-F291-4D74-BD8B-7C70315BA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535950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F785F-9322-4B08-ADC7-7C0DBACE029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13A2-F291-4D74-BD8B-7C70315BA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640146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F785F-9322-4B08-ADC7-7C0DBACE029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13A2-F291-4D74-BD8B-7C70315BA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31401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F785F-9322-4B08-ADC7-7C0DBACE029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13A2-F291-4D74-BD8B-7C70315BA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9952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CF785F-9322-4B08-ADC7-7C0DBACE029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513A2-F291-4D74-BD8B-7C70315BA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384799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CF785F-9322-4B08-ADC7-7C0DBACE0292}" type="datetimeFigureOut">
              <a:rPr lang="de-DE" smtClean="0"/>
              <a:t>15.1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E513A2-F291-4D74-BD8B-7C70315BADF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297558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/>
          <p:cNvSpPr/>
          <p:nvPr/>
        </p:nvSpPr>
        <p:spPr>
          <a:xfrm>
            <a:off x="2898530" y="262076"/>
            <a:ext cx="6096000" cy="6186309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GB" b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GB" b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terial</a:t>
            </a:r>
          </a:p>
          <a:p>
            <a:pPr algn="ctr">
              <a:lnSpc>
                <a:spcPct val="150000"/>
              </a:lnSpc>
            </a:pPr>
            <a:r>
              <a:rPr lang="en-GB" b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o</a:t>
            </a:r>
            <a:endParaRPr lang="de-DE" b="1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endParaRPr lang="en-GB" sz="1200" b="1" smtClean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etwork </a:t>
            </a:r>
            <a:r>
              <a:rPr lang="en-GB" sz="1200" b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ta-analysis of transcriptome expression changes in different manifestations of dengue virus infection</a:t>
            </a:r>
            <a:endParaRPr lang="de-DE" sz="120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de-DE" sz="120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de-DE" sz="12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hristine Winter</a:t>
            </a:r>
            <a:r>
              <a:rPr lang="de-DE" sz="1200" baseline="300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de-DE" sz="12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António A. R. Cama</a:t>
            </a:r>
            <a:r>
              <a:rPr lang="de-DE" sz="12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ã</a:t>
            </a:r>
            <a:r>
              <a:rPr lang="de-DE" sz="12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</a:t>
            </a:r>
            <a:r>
              <a:rPr lang="de-DE" sz="1200" baseline="300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de-DE" sz="12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Imke Steffen</a:t>
            </a:r>
            <a:r>
              <a:rPr lang="de-DE" sz="1200" baseline="300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de-DE" sz="12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Klaus Jung</a:t>
            </a:r>
            <a:r>
              <a:rPr lang="de-DE" sz="1200" baseline="300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*</a:t>
            </a:r>
            <a:endParaRPr lang="de-DE" sz="120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de-DE" sz="12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) Institute for Animal Breeding and Genetics, University of Veterinary Medicine Hannover, Hannover, Germany</a:t>
            </a:r>
            <a:endParaRPr lang="de-DE" sz="120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) Department of Biochemistry and Research Center for Emerging Infections and Zoonoses, University of Veterinary Medicine Hannover, Hannover, </a:t>
            </a:r>
            <a:r>
              <a:rPr lang="en-GB" sz="120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rmany</a:t>
            </a: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endParaRPr lang="en-GB" sz="120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endParaRPr lang="en-GB" sz="1200" smtClean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endParaRPr lang="en-GB" sz="120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="1" smtClean="0"/>
              <a:t>Supplementary Figures S3: </a:t>
            </a:r>
            <a:r>
              <a:rPr lang="en-GB" sz="1200" smtClean="0"/>
              <a:t>Mutual </a:t>
            </a:r>
            <a:r>
              <a:rPr lang="en-GB" sz="1200"/>
              <a:t>information networks based on top genes from each comparison between the three groups of patients, as identified from the network meta-analysis. Considering a comparison A versus B, blue edges indicate an increased correlation in samples from A compared to the correlation observed in B, while red edges indicate a stronger correlation in B compared to that in A. The thicker an edge, the stronger the observed correlation</a:t>
            </a:r>
            <a:r>
              <a:rPr lang="en-GB" sz="1200" smtClean="0"/>
              <a:t>.</a:t>
            </a:r>
            <a:endParaRPr lang="en-GB" sz="120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915736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/>
          <p:cNvGrpSpPr/>
          <p:nvPr/>
        </p:nvGrpSpPr>
        <p:grpSpPr>
          <a:xfrm>
            <a:off x="2895600" y="233362"/>
            <a:ext cx="7950161" cy="6391275"/>
            <a:chOff x="2895600" y="233362"/>
            <a:chExt cx="7950161" cy="6391275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895600" y="233362"/>
              <a:ext cx="6400800" cy="6391275"/>
            </a:xfrm>
            <a:prstGeom prst="rect">
              <a:avLst/>
            </a:prstGeom>
          </p:spPr>
        </p:pic>
        <p:pic>
          <p:nvPicPr>
            <p:cNvPr id="3" name="Grafik 2"/>
            <p:cNvPicPr>
              <a:picLocks noChangeAspect="1"/>
            </p:cNvPicPr>
            <p:nvPr/>
          </p:nvPicPr>
          <p:blipFill rotWithShape="1">
            <a:blip r:embed="rId3"/>
            <a:srcRect l="14057" t="14049" r="44734" b="16066"/>
            <a:stretch/>
          </p:blipFill>
          <p:spPr>
            <a:xfrm>
              <a:off x="9609992" y="2382714"/>
              <a:ext cx="1235769" cy="20925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299286574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/>
          <p:cNvGrpSpPr/>
          <p:nvPr/>
        </p:nvGrpSpPr>
        <p:grpSpPr>
          <a:xfrm>
            <a:off x="2895600" y="233362"/>
            <a:ext cx="7950161" cy="6391275"/>
            <a:chOff x="2895600" y="233362"/>
            <a:chExt cx="7950161" cy="6391275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895600" y="233362"/>
              <a:ext cx="6400800" cy="6391275"/>
            </a:xfrm>
            <a:prstGeom prst="rect">
              <a:avLst/>
            </a:prstGeom>
          </p:spPr>
        </p:pic>
        <p:pic>
          <p:nvPicPr>
            <p:cNvPr id="3" name="Grafik 2"/>
            <p:cNvPicPr>
              <a:picLocks noChangeAspect="1"/>
            </p:cNvPicPr>
            <p:nvPr/>
          </p:nvPicPr>
          <p:blipFill rotWithShape="1">
            <a:blip r:embed="rId3"/>
            <a:srcRect l="14057" t="14049" r="44734" b="16066"/>
            <a:stretch/>
          </p:blipFill>
          <p:spPr>
            <a:xfrm>
              <a:off x="9609992" y="2382714"/>
              <a:ext cx="1235769" cy="20925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37511583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ieren 2"/>
          <p:cNvGrpSpPr/>
          <p:nvPr/>
        </p:nvGrpSpPr>
        <p:grpSpPr>
          <a:xfrm>
            <a:off x="2895600" y="233362"/>
            <a:ext cx="7950161" cy="6391275"/>
            <a:chOff x="2895600" y="233362"/>
            <a:chExt cx="7950161" cy="6391275"/>
          </a:xfrm>
        </p:grpSpPr>
        <p:pic>
          <p:nvPicPr>
            <p:cNvPr id="6" name="Grafik 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895600" y="233362"/>
              <a:ext cx="6400800" cy="6391275"/>
            </a:xfrm>
            <a:prstGeom prst="rect">
              <a:avLst/>
            </a:prstGeom>
          </p:spPr>
        </p:pic>
        <p:pic>
          <p:nvPicPr>
            <p:cNvPr id="2" name="Grafik 1"/>
            <p:cNvPicPr>
              <a:picLocks noChangeAspect="1"/>
            </p:cNvPicPr>
            <p:nvPr/>
          </p:nvPicPr>
          <p:blipFill rotWithShape="1">
            <a:blip r:embed="rId3"/>
            <a:srcRect l="14057" t="14049" r="44734" b="16066"/>
            <a:stretch/>
          </p:blipFill>
          <p:spPr>
            <a:xfrm>
              <a:off x="9609992" y="2382714"/>
              <a:ext cx="1235769" cy="20925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1250619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95600" y="233362"/>
            <a:ext cx="6400800" cy="6391275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3"/>
          <a:srcRect r="45440"/>
          <a:stretch/>
        </p:blipFill>
        <p:spPr>
          <a:xfrm>
            <a:off x="9478733" y="2324694"/>
            <a:ext cx="1230298" cy="2251584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1378158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2913185" y="233360"/>
            <a:ext cx="7932576" cy="6391275"/>
            <a:chOff x="2913185" y="233360"/>
            <a:chExt cx="7932576" cy="6391275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913185" y="233360"/>
              <a:ext cx="6400800" cy="6391275"/>
            </a:xfrm>
            <a:prstGeom prst="rect">
              <a:avLst/>
            </a:prstGeom>
          </p:spPr>
        </p:pic>
        <p:pic>
          <p:nvPicPr>
            <p:cNvPr id="4" name="Grafik 3"/>
            <p:cNvPicPr>
              <a:picLocks noChangeAspect="1"/>
            </p:cNvPicPr>
            <p:nvPr/>
          </p:nvPicPr>
          <p:blipFill rotWithShape="1">
            <a:blip r:embed="rId3"/>
            <a:srcRect l="14057" t="14049" r="44734" b="16066"/>
            <a:stretch/>
          </p:blipFill>
          <p:spPr>
            <a:xfrm>
              <a:off x="9609992" y="2382714"/>
              <a:ext cx="1235769" cy="20925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33328235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2895600" y="233362"/>
            <a:ext cx="7950161" cy="6391275"/>
            <a:chOff x="2895600" y="233362"/>
            <a:chExt cx="7950161" cy="6391275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895600" y="233362"/>
              <a:ext cx="6400800" cy="6391275"/>
            </a:xfrm>
            <a:prstGeom prst="rect">
              <a:avLst/>
            </a:prstGeom>
          </p:spPr>
        </p:pic>
        <p:pic>
          <p:nvPicPr>
            <p:cNvPr id="4" name="Grafik 3"/>
            <p:cNvPicPr>
              <a:picLocks noChangeAspect="1"/>
            </p:cNvPicPr>
            <p:nvPr/>
          </p:nvPicPr>
          <p:blipFill rotWithShape="1">
            <a:blip r:embed="rId3"/>
            <a:srcRect l="14057" t="14049" r="44734" b="16066"/>
            <a:stretch/>
          </p:blipFill>
          <p:spPr>
            <a:xfrm>
              <a:off x="9609992" y="2382714"/>
              <a:ext cx="1235769" cy="20925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97344133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2895600" y="233362"/>
            <a:ext cx="7950161" cy="6391275"/>
            <a:chOff x="2895600" y="233362"/>
            <a:chExt cx="7950161" cy="6391275"/>
          </a:xfrm>
        </p:grpSpPr>
        <p:pic>
          <p:nvPicPr>
            <p:cNvPr id="4" name="Grafik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895600" y="233362"/>
              <a:ext cx="6400800" cy="6391275"/>
            </a:xfrm>
            <a:prstGeom prst="rect">
              <a:avLst/>
            </a:prstGeom>
          </p:spPr>
        </p:pic>
        <p:pic>
          <p:nvPicPr>
            <p:cNvPr id="3" name="Grafik 2"/>
            <p:cNvPicPr>
              <a:picLocks noChangeAspect="1"/>
            </p:cNvPicPr>
            <p:nvPr/>
          </p:nvPicPr>
          <p:blipFill rotWithShape="1">
            <a:blip r:embed="rId3"/>
            <a:srcRect l="14057" t="14049" r="44734" b="16066"/>
            <a:stretch/>
          </p:blipFill>
          <p:spPr>
            <a:xfrm>
              <a:off x="9609992" y="2382714"/>
              <a:ext cx="1235769" cy="20925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240511004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2895600" y="233362"/>
            <a:ext cx="7950161" cy="6391275"/>
            <a:chOff x="2895600" y="233362"/>
            <a:chExt cx="7950161" cy="6391275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895600" y="233362"/>
              <a:ext cx="6400800" cy="6391275"/>
            </a:xfrm>
            <a:prstGeom prst="rect">
              <a:avLst/>
            </a:prstGeom>
          </p:spPr>
        </p:pic>
        <p:pic>
          <p:nvPicPr>
            <p:cNvPr id="4" name="Grafik 3"/>
            <p:cNvPicPr>
              <a:picLocks noChangeAspect="1"/>
            </p:cNvPicPr>
            <p:nvPr/>
          </p:nvPicPr>
          <p:blipFill rotWithShape="1">
            <a:blip r:embed="rId3"/>
            <a:srcRect l="14057" t="14049" r="44734" b="16066"/>
            <a:stretch/>
          </p:blipFill>
          <p:spPr>
            <a:xfrm>
              <a:off x="9609992" y="2382714"/>
              <a:ext cx="1235769" cy="20925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422816685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/>
          <p:cNvGrpSpPr/>
          <p:nvPr/>
        </p:nvGrpSpPr>
        <p:grpSpPr>
          <a:xfrm>
            <a:off x="2895600" y="233362"/>
            <a:ext cx="7950161" cy="6391275"/>
            <a:chOff x="2895600" y="233362"/>
            <a:chExt cx="7950161" cy="6391275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895600" y="233362"/>
              <a:ext cx="6400800" cy="6391275"/>
            </a:xfrm>
            <a:prstGeom prst="rect">
              <a:avLst/>
            </a:prstGeom>
          </p:spPr>
        </p:pic>
        <p:pic>
          <p:nvPicPr>
            <p:cNvPr id="3" name="Grafik 2"/>
            <p:cNvPicPr>
              <a:picLocks noChangeAspect="1"/>
            </p:cNvPicPr>
            <p:nvPr/>
          </p:nvPicPr>
          <p:blipFill rotWithShape="1">
            <a:blip r:embed="rId3"/>
            <a:srcRect l="14057" t="14049" r="44734" b="16066"/>
            <a:stretch/>
          </p:blipFill>
          <p:spPr>
            <a:xfrm>
              <a:off x="9609992" y="2382714"/>
              <a:ext cx="1235769" cy="20925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347448998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/>
          <p:cNvGrpSpPr/>
          <p:nvPr/>
        </p:nvGrpSpPr>
        <p:grpSpPr>
          <a:xfrm>
            <a:off x="2895600" y="233362"/>
            <a:ext cx="7950161" cy="6391275"/>
            <a:chOff x="2895600" y="233362"/>
            <a:chExt cx="7950161" cy="6391275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895600" y="233362"/>
              <a:ext cx="6400800" cy="6391275"/>
            </a:xfrm>
            <a:prstGeom prst="rect">
              <a:avLst/>
            </a:prstGeom>
          </p:spPr>
        </p:pic>
        <p:pic>
          <p:nvPicPr>
            <p:cNvPr id="3" name="Grafik 2"/>
            <p:cNvPicPr>
              <a:picLocks noChangeAspect="1"/>
            </p:cNvPicPr>
            <p:nvPr/>
          </p:nvPicPr>
          <p:blipFill rotWithShape="1">
            <a:blip r:embed="rId3"/>
            <a:srcRect l="14057" t="14049" r="44734" b="16066"/>
            <a:stretch/>
          </p:blipFill>
          <p:spPr>
            <a:xfrm>
              <a:off x="9609992" y="2382714"/>
              <a:ext cx="1235769" cy="20925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10994606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4</Words>
  <Application>Microsoft Office PowerPoint</Application>
  <PresentationFormat>Breitbild</PresentationFormat>
  <Paragraphs>13</Paragraphs>
  <Slides>1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1</vt:i4>
      </vt:variant>
    </vt:vector>
  </HeadingPairs>
  <TitlesOfParts>
    <vt:vector size="16" baseType="lpstr"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TiH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ung, Klaus</dc:creator>
  <cp:lastModifiedBy>Jung, Klaus</cp:lastModifiedBy>
  <cp:revision>28</cp:revision>
  <dcterms:created xsi:type="dcterms:W3CDTF">2021-05-27T08:53:18Z</dcterms:created>
  <dcterms:modified xsi:type="dcterms:W3CDTF">2021-12-15T13:41:01Z</dcterms:modified>
</cp:coreProperties>
</file>